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howGuides="1">
      <p:cViewPr varScale="1">
        <p:scale>
          <a:sx n="95" d="100"/>
          <a:sy n="95" d="100"/>
        </p:scale>
        <p:origin x="1032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lle Wang" userId="c1cb688c-6b77-4085-ac84-7541e7c2e6f5" providerId="ADAL" clId="{1D63BE53-3835-47BF-ACCF-59F5C47D8891}"/>
    <pc:docChg chg="modSld">
      <pc:chgData name="Belle Wang" userId="c1cb688c-6b77-4085-ac84-7541e7c2e6f5" providerId="ADAL" clId="{1D63BE53-3835-47BF-ACCF-59F5C47D8891}" dt="2023-06-27T07:24:27.254" v="48" actId="114"/>
      <pc:docMkLst>
        <pc:docMk/>
      </pc:docMkLst>
      <pc:sldChg chg="addSp modSp mod">
        <pc:chgData name="Belle Wang" userId="c1cb688c-6b77-4085-ac84-7541e7c2e6f5" providerId="ADAL" clId="{1D63BE53-3835-47BF-ACCF-59F5C47D8891}" dt="2023-06-27T07:24:27.254" v="48" actId="114"/>
        <pc:sldMkLst>
          <pc:docMk/>
          <pc:sldMk cId="1689364281" sldId="256"/>
        </pc:sldMkLst>
        <pc:spChg chg="add mod">
          <ac:chgData name="Belle Wang" userId="c1cb688c-6b77-4085-ac84-7541e7c2e6f5" providerId="ADAL" clId="{1D63BE53-3835-47BF-ACCF-59F5C47D8891}" dt="2023-06-27T07:24:27.254" v="48" actId="114"/>
          <ac:spMkLst>
            <pc:docMk/>
            <pc:sldMk cId="1689364281" sldId="256"/>
            <ac:spMk id="4" creationId="{ACC12F5A-59F6-EBE4-70E6-15B08B2249F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BE820-78B2-9606-FDA6-5B243E05AE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583118-6637-18AA-755F-7404BA734A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BFAD8-53AA-46CF-D70E-DF8C252C6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E355C8-D8A5-E334-7F76-9377A35B6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F60DD-ED86-A1D8-1173-5C3E8C09E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059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AAEC91-7BCE-AD40-F1C9-792E22941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046A11-27F6-ED11-10D5-F3B3BD61F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5C74D2-3DCF-FB70-BF59-4C47339D9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F5F668-9A23-BC42-0FD9-9387F76C6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1CEE2-0972-450D-0A68-BC628ECA9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3727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9603AF-6EBC-2E09-E5AA-182B7A52C4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159064-E3BD-01D6-0435-BD11360C1C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3EC62-E8CD-5D57-5745-57805C7CC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A37DFC-800E-11E9-0C32-C765F7E38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D4E948-7F79-2D11-A91A-1D4C7CE42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48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D2B69-3666-4543-EC10-872E86589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93B0E6-06E9-706D-269D-EB7B2AB33A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300837-1F13-FB9C-2307-A7CF35CFC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17EAC-895A-C110-384E-B0FE0F4BA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C7CEA-8E7D-0021-BB84-27B9EDBC9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4066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91845-6DD7-2A2A-7364-03FFB30C03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8CB1C9-5A2D-BCEC-0141-3EEF3B177A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1E5AE1-0933-16F3-2B7D-70E32C3F6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B0054-2E59-7447-DBE1-0F7FA4F41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64D1A6-6615-FB0B-663C-C4755AEC0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047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B5F71-2E63-F186-4419-E4C08EE6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89801A-43D8-ABEE-66EC-38FD1BC3F1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E9101F-5160-4A53-DF4A-A28C9B33C7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AFCC3C-0172-CFDD-6A27-419D8BA81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0FF0BD-31A3-79A6-39D2-773EA5F46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022CE5-D371-C0EA-1ECC-3DC345516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4380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24258-7B32-59C1-0548-BD4CDA7C9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4DD13F-C583-AE06-30C3-173D3EF87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CEF9EF-ED23-946D-D30B-FBC4B39C8A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BC9C57-DD04-67D8-1C5D-87B531D057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168368-E526-F859-AECF-0F76E2077C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E0BC30-FD76-2399-2FC9-1ED2E9A1D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5CA827-81C9-AE6B-4749-6E8CEDD58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C7C63D-496A-ED79-53CE-18FFF83A6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856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34E7A-79F1-42E3-5D99-E6D56EEE2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8D1042-CE9C-62EC-2B20-F5ACF5956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FEBC70-6B02-E9B8-5EF7-850C1AACA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A76374-01A0-D99D-68B2-A3B7DA3D4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2726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F2B0D6-4E29-F36B-4BDD-88B1AC35D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985CE7-FA36-FEC6-AF98-836099E5C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E37FD1-AE34-33E6-AAF6-A2D32D284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521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678E9-0299-1F04-A859-8C7C01A3F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A339F5-7338-C35F-CB80-0879175F45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2349F0-A767-02C8-539A-45DE22B27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E46CD7-E6F6-D23C-F010-6D7BFFC0C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C2BB56-04F0-6509-F38F-2FB25DF1B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E5383-F0D2-B4D6-BE05-1A45B2F55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2156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F30F2-EFCB-5CC4-DFDC-751CFB8A0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9CBCCF-91D3-C51E-6AF9-51722436AA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897B45-490E-75F1-6E9E-02532FA7B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5AF591-42D0-774D-CADF-AAC4C0798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86B49E-FFFD-A16E-0685-E555BDDC6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E97CA8-150F-8BC8-157C-7851F288D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7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6BCB47-32E3-EFD8-CEB7-C3EEB3F9DF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779C5B-B0FB-6D49-EC91-8F2401C2A8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F5C06C-F07B-B4B3-D607-C7B4FA2619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843C9-8295-D94D-81F2-FA83FB26856E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3A64B-F3D2-6483-5C43-8FD197A102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1613C-2882-6472-1583-9900A9A28C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AF5B8-7567-144A-8168-B5B50CDAC7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692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>
            <a:extLst>
              <a:ext uri="{FF2B5EF4-FFF2-40B4-BE49-F238E27FC236}">
                <a16:creationId xmlns:a16="http://schemas.microsoft.com/office/drawing/2014/main" id="{E1134FA2-EBDE-BAF3-CEFA-623AE91C820D}"/>
              </a:ext>
            </a:extLst>
          </p:cNvPr>
          <p:cNvGrpSpPr/>
          <p:nvPr/>
        </p:nvGrpSpPr>
        <p:grpSpPr>
          <a:xfrm>
            <a:off x="152399" y="195943"/>
            <a:ext cx="3418115" cy="3668486"/>
            <a:chOff x="152399" y="195943"/>
            <a:chExt cx="3418115" cy="3668486"/>
          </a:xfrm>
        </p:grpSpPr>
        <p:pic>
          <p:nvPicPr>
            <p:cNvPr id="10" name="Picture 9" descr="A picture containing text, dark&#10;&#10;Description automatically generated">
              <a:extLst>
                <a:ext uri="{FF2B5EF4-FFF2-40B4-BE49-F238E27FC236}">
                  <a16:creationId xmlns:a16="http://schemas.microsoft.com/office/drawing/2014/main" id="{010FC49B-2DEE-59B7-5492-20F6ECB225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5561" t="23590" r="28952" b="10965"/>
            <a:stretch/>
          </p:blipFill>
          <p:spPr>
            <a:xfrm flipH="1">
              <a:off x="152399" y="195943"/>
              <a:ext cx="3418115" cy="3668486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5D248D9-1701-269D-ADE5-A8CC504A80FD}"/>
                </a:ext>
              </a:extLst>
            </p:cNvPr>
            <p:cNvSpPr txBox="1"/>
            <p:nvPr/>
          </p:nvSpPr>
          <p:spPr>
            <a:xfrm>
              <a:off x="2166256" y="2149929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35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B9995E2-0923-6FCB-260E-9071EF440A72}"/>
                </a:ext>
              </a:extLst>
            </p:cNvPr>
            <p:cNvSpPr txBox="1"/>
            <p:nvPr/>
          </p:nvSpPr>
          <p:spPr>
            <a:xfrm>
              <a:off x="2166256" y="1453243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55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ED859CB-CB82-BF8E-F638-E61211CCF98F}"/>
                </a:ext>
              </a:extLst>
            </p:cNvPr>
            <p:cNvSpPr txBox="1"/>
            <p:nvPr/>
          </p:nvSpPr>
          <p:spPr>
            <a:xfrm>
              <a:off x="2166256" y="1118764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70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117C91D-B0B1-5E47-C568-B97387F0E0A1}"/>
                </a:ext>
              </a:extLst>
            </p:cNvPr>
            <p:cNvSpPr txBox="1"/>
            <p:nvPr/>
          </p:nvSpPr>
          <p:spPr>
            <a:xfrm>
              <a:off x="2120571" y="856015"/>
              <a:ext cx="777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100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A460864-FF65-1024-72BE-839188AC07A6}"/>
                </a:ext>
              </a:extLst>
            </p:cNvPr>
            <p:cNvSpPr txBox="1"/>
            <p:nvPr/>
          </p:nvSpPr>
          <p:spPr>
            <a:xfrm>
              <a:off x="2120571" y="666030"/>
              <a:ext cx="777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130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B2DF3EC-1C38-C51A-7E29-CE5947F2FBC1}"/>
                </a:ext>
              </a:extLst>
            </p:cNvPr>
            <p:cNvSpPr txBox="1"/>
            <p:nvPr/>
          </p:nvSpPr>
          <p:spPr>
            <a:xfrm>
              <a:off x="2120571" y="467083"/>
              <a:ext cx="777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250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7A1B09C-5DC7-3495-43EA-D6996C8DF152}"/>
                </a:ext>
              </a:extLst>
            </p:cNvPr>
            <p:cNvSpPr txBox="1"/>
            <p:nvPr/>
          </p:nvSpPr>
          <p:spPr>
            <a:xfrm>
              <a:off x="2166256" y="2605638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25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D37D951-AE77-5880-D513-E038943E214E}"/>
                </a:ext>
              </a:extLst>
            </p:cNvPr>
            <p:cNvSpPr txBox="1"/>
            <p:nvPr/>
          </p:nvSpPr>
          <p:spPr>
            <a:xfrm>
              <a:off x="2166256" y="3340427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10 </a:t>
              </a:r>
              <a:r>
                <a:rPr lang="en-GB" sz="1400" dirty="0" err="1"/>
                <a:t>kDa</a:t>
              </a:r>
              <a:endParaRPr lang="en-GB" sz="1400" dirty="0"/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4EDFCFD-B6F2-36FE-49BD-4431289DEDB2}"/>
              </a:ext>
            </a:extLst>
          </p:cNvPr>
          <p:cNvGrpSpPr/>
          <p:nvPr/>
        </p:nvGrpSpPr>
        <p:grpSpPr>
          <a:xfrm>
            <a:off x="3776301" y="195943"/>
            <a:ext cx="4141480" cy="3668486"/>
            <a:chOff x="7384507" y="195943"/>
            <a:chExt cx="4141480" cy="3668486"/>
          </a:xfrm>
        </p:grpSpPr>
        <p:pic>
          <p:nvPicPr>
            <p:cNvPr id="29" name="Picture 28" descr="A picture containing white&#10;&#10;Description automatically generated">
              <a:extLst>
                <a:ext uri="{FF2B5EF4-FFF2-40B4-BE49-F238E27FC236}">
                  <a16:creationId xmlns:a16="http://schemas.microsoft.com/office/drawing/2014/main" id="{CCB44FDD-4EFC-8A6E-7A8A-EA43212436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5168" t="25413" r="30569" b="17153"/>
            <a:stretch/>
          </p:blipFill>
          <p:spPr>
            <a:xfrm flipH="1">
              <a:off x="7384507" y="195943"/>
              <a:ext cx="3676348" cy="3668486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7F497ED-8008-09A5-BC31-5064455798D6}"/>
                </a:ext>
              </a:extLst>
            </p:cNvPr>
            <p:cNvSpPr txBox="1"/>
            <p:nvPr/>
          </p:nvSpPr>
          <p:spPr>
            <a:xfrm rot="19145699">
              <a:off x="7846227" y="2588175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N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C49E0CF-6E41-55F1-BAFF-FBF57EBB218E}"/>
                </a:ext>
              </a:extLst>
            </p:cNvPr>
            <p:cNvSpPr txBox="1"/>
            <p:nvPr/>
          </p:nvSpPr>
          <p:spPr>
            <a:xfrm rot="19145699">
              <a:off x="8170283" y="2576103"/>
              <a:ext cx="4764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B8486DA-1D82-5015-5C58-C91D13A99D41}"/>
                </a:ext>
              </a:extLst>
            </p:cNvPr>
            <p:cNvSpPr txBox="1"/>
            <p:nvPr/>
          </p:nvSpPr>
          <p:spPr>
            <a:xfrm rot="19145699">
              <a:off x="8186170" y="2714134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+MS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E649FA4-B80B-519A-AD88-1B01D73C51D2}"/>
                </a:ext>
              </a:extLst>
            </p:cNvPr>
            <p:cNvSpPr txBox="1"/>
            <p:nvPr/>
          </p:nvSpPr>
          <p:spPr>
            <a:xfrm rot="19145699">
              <a:off x="9509242" y="2588176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N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F2CF363-77FB-B497-8FEC-802C3060290C}"/>
                </a:ext>
              </a:extLst>
            </p:cNvPr>
            <p:cNvSpPr txBox="1"/>
            <p:nvPr/>
          </p:nvSpPr>
          <p:spPr>
            <a:xfrm rot="19145699">
              <a:off x="9822412" y="2576104"/>
              <a:ext cx="4764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3611E25-DC90-5C61-7726-2A57E25C5E4C}"/>
                </a:ext>
              </a:extLst>
            </p:cNvPr>
            <p:cNvSpPr txBox="1"/>
            <p:nvPr/>
          </p:nvSpPr>
          <p:spPr>
            <a:xfrm rot="19145699">
              <a:off x="9860071" y="2714135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+MS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1CECC24-12BF-FD2A-1D18-CBAC0E9BBFE0}"/>
                </a:ext>
              </a:extLst>
            </p:cNvPr>
            <p:cNvSpPr txBox="1"/>
            <p:nvPr/>
          </p:nvSpPr>
          <p:spPr>
            <a:xfrm>
              <a:off x="8009437" y="3318068"/>
              <a:ext cx="798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i="1" dirty="0"/>
                <a:t>In vivo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3D1714E-0054-989A-AAB3-B05B75F04F54}"/>
                </a:ext>
              </a:extLst>
            </p:cNvPr>
            <p:cNvSpPr txBox="1"/>
            <p:nvPr/>
          </p:nvSpPr>
          <p:spPr>
            <a:xfrm>
              <a:off x="9608986" y="3348846"/>
              <a:ext cx="8435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i="1" dirty="0"/>
                <a:t>In vitro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3C9D5FD9-7466-32A1-30A7-595FFE43AFA3}"/>
                </a:ext>
              </a:extLst>
            </p:cNvPr>
            <p:cNvSpPr/>
            <p:nvPr/>
          </p:nvSpPr>
          <p:spPr>
            <a:xfrm>
              <a:off x="7991608" y="1611086"/>
              <a:ext cx="2743200" cy="5388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324423F-F206-A397-20F4-4F6C8D9C3ABE}"/>
                </a:ext>
              </a:extLst>
            </p:cNvPr>
            <p:cNvSpPr/>
            <p:nvPr/>
          </p:nvSpPr>
          <p:spPr>
            <a:xfrm>
              <a:off x="7990441" y="2198914"/>
              <a:ext cx="2743200" cy="2190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4B3BF2C-8B1C-E711-1D44-C3272A76B5BB}"/>
                </a:ext>
              </a:extLst>
            </p:cNvPr>
            <p:cNvSpPr txBox="1"/>
            <p:nvPr/>
          </p:nvSpPr>
          <p:spPr>
            <a:xfrm>
              <a:off x="10922937" y="2173012"/>
              <a:ext cx="6030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/>
                <a:t>GAPDH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8AD0BDE-E36D-A5AC-2349-5DB5B46BC5B7}"/>
                </a:ext>
              </a:extLst>
            </p:cNvPr>
            <p:cNvSpPr txBox="1"/>
            <p:nvPr/>
          </p:nvSpPr>
          <p:spPr>
            <a:xfrm>
              <a:off x="10922937" y="1749702"/>
              <a:ext cx="6030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/>
                <a:t>ERK1/2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B3872A1-63C2-66C7-3098-64857878BD06}"/>
              </a:ext>
            </a:extLst>
          </p:cNvPr>
          <p:cNvGrpSpPr/>
          <p:nvPr/>
        </p:nvGrpSpPr>
        <p:grpSpPr>
          <a:xfrm>
            <a:off x="8113245" y="195943"/>
            <a:ext cx="3926356" cy="3668486"/>
            <a:chOff x="8113245" y="195943"/>
            <a:chExt cx="3926356" cy="3668486"/>
          </a:xfrm>
        </p:grpSpPr>
        <p:pic>
          <p:nvPicPr>
            <p:cNvPr id="12" name="Picture 11" descr="A picture containing white, black&#10;&#10;Description automatically generated">
              <a:extLst>
                <a:ext uri="{FF2B5EF4-FFF2-40B4-BE49-F238E27FC236}">
                  <a16:creationId xmlns:a16="http://schemas.microsoft.com/office/drawing/2014/main" id="{E9425D15-F344-70AE-44B0-A7152C71E6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5561" t="23590" r="28952" b="10965"/>
            <a:stretch/>
          </p:blipFill>
          <p:spPr>
            <a:xfrm flipH="1">
              <a:off x="8113245" y="195943"/>
              <a:ext cx="3418115" cy="3668486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C7CB9FF-797D-6FD4-89F2-A335E112CEA5}"/>
                </a:ext>
              </a:extLst>
            </p:cNvPr>
            <p:cNvSpPr txBox="1"/>
            <p:nvPr/>
          </p:nvSpPr>
          <p:spPr>
            <a:xfrm rot="19145699">
              <a:off x="8432452" y="2579756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9B14C4D-74A0-6C85-09AC-6BBA0E01CAB5}"/>
                </a:ext>
              </a:extLst>
            </p:cNvPr>
            <p:cNvSpPr txBox="1"/>
            <p:nvPr/>
          </p:nvSpPr>
          <p:spPr>
            <a:xfrm rot="19145699">
              <a:off x="8756508" y="2567684"/>
              <a:ext cx="4764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AB9435B-51A2-2631-9124-475C5FDC1918}"/>
                </a:ext>
              </a:extLst>
            </p:cNvPr>
            <p:cNvSpPr txBox="1"/>
            <p:nvPr/>
          </p:nvSpPr>
          <p:spPr>
            <a:xfrm rot="19145699">
              <a:off x="8772395" y="2705715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+MSC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6FFEBE4-2BA1-037F-E3C1-EDAD32DADE8E}"/>
                </a:ext>
              </a:extLst>
            </p:cNvPr>
            <p:cNvSpPr txBox="1"/>
            <p:nvPr/>
          </p:nvSpPr>
          <p:spPr>
            <a:xfrm rot="19145699">
              <a:off x="9866865" y="2579757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5E910B6-007B-D19B-32D1-B21BE7A8AC26}"/>
                </a:ext>
              </a:extLst>
            </p:cNvPr>
            <p:cNvSpPr txBox="1"/>
            <p:nvPr/>
          </p:nvSpPr>
          <p:spPr>
            <a:xfrm rot="19145699">
              <a:off x="10180035" y="2567685"/>
              <a:ext cx="4764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435E087-A411-2CF9-44F4-9648AB8C8810}"/>
                </a:ext>
              </a:extLst>
            </p:cNvPr>
            <p:cNvSpPr txBox="1"/>
            <p:nvPr/>
          </p:nvSpPr>
          <p:spPr>
            <a:xfrm rot="19145699">
              <a:off x="10217694" y="2705716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EX+MSC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0CBAC14-7A03-2AD2-066C-86284E8511FB}"/>
                </a:ext>
              </a:extLst>
            </p:cNvPr>
            <p:cNvSpPr txBox="1"/>
            <p:nvPr/>
          </p:nvSpPr>
          <p:spPr>
            <a:xfrm>
              <a:off x="8595662" y="3309649"/>
              <a:ext cx="798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i="1" dirty="0"/>
                <a:t>In vivo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B9EE57C-B2D0-70C9-EC19-B0639BCC690F}"/>
                </a:ext>
              </a:extLst>
            </p:cNvPr>
            <p:cNvSpPr txBox="1"/>
            <p:nvPr/>
          </p:nvSpPr>
          <p:spPr>
            <a:xfrm>
              <a:off x="9966609" y="3340427"/>
              <a:ext cx="8435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i="1" dirty="0"/>
                <a:t>In vitro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52D2F1F6-BFC3-6EA3-50B2-107408AC97B1}"/>
                </a:ext>
              </a:extLst>
            </p:cNvPr>
            <p:cNvSpPr/>
            <p:nvPr/>
          </p:nvSpPr>
          <p:spPr>
            <a:xfrm>
              <a:off x="8483360" y="1611086"/>
              <a:ext cx="2743200" cy="5388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C7D6EB-93D7-C1DA-229E-9CBB039612CE}"/>
                </a:ext>
              </a:extLst>
            </p:cNvPr>
            <p:cNvSpPr txBox="1"/>
            <p:nvPr/>
          </p:nvSpPr>
          <p:spPr>
            <a:xfrm>
              <a:off x="11321135" y="1749702"/>
              <a:ext cx="7184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/>
                <a:t>P-ERK1/2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CC12F5A-59F6-EBE4-70E6-15B08B2249FD}"/>
              </a:ext>
            </a:extLst>
          </p:cNvPr>
          <p:cNvSpPr txBox="1"/>
          <p:nvPr/>
        </p:nvSpPr>
        <p:spPr>
          <a:xfrm>
            <a:off x="113415" y="4172204"/>
            <a:ext cx="119261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Figure S1. Original blot of ERK1/2 protein expression for</a:t>
            </a:r>
            <a:r>
              <a:rPr lang="en-US" sz="1800" i="1" dirty="0"/>
              <a:t> in vitro </a:t>
            </a:r>
            <a:r>
              <a:rPr lang="en-US" i="1" dirty="0"/>
              <a:t>muscle</a:t>
            </a:r>
            <a:r>
              <a:rPr lang="en-US" sz="1800" dirty="0"/>
              <a:t> and </a:t>
            </a:r>
            <a:r>
              <a:rPr lang="en-US" sz="1800" i="1" dirty="0"/>
              <a:t>in vivo</a:t>
            </a:r>
            <a:r>
              <a:rPr lang="en-US" sz="1800" dirty="0"/>
              <a:t> </a:t>
            </a:r>
            <a:r>
              <a:rPr lang="en-US" dirty="0"/>
              <a:t>cell </a:t>
            </a:r>
            <a:r>
              <a:rPr lang="en-US" sz="1800" dirty="0"/>
              <a:t>samples.</a:t>
            </a:r>
            <a:endParaRPr lang="en-HK" dirty="0"/>
          </a:p>
        </p:txBody>
      </p:sp>
    </p:spTree>
    <p:extLst>
      <p:ext uri="{BB962C8B-B14F-4D97-AF65-F5344CB8AC3E}">
        <p14:creationId xmlns:p14="http://schemas.microsoft.com/office/powerpoint/2010/main" val="1689364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66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Yu Hsuan Belle</dc:creator>
  <cp:lastModifiedBy>Belle Wang</cp:lastModifiedBy>
  <cp:revision>3</cp:revision>
  <dcterms:created xsi:type="dcterms:W3CDTF">2023-02-11T11:10:23Z</dcterms:created>
  <dcterms:modified xsi:type="dcterms:W3CDTF">2023-06-27T07:24:32Z</dcterms:modified>
</cp:coreProperties>
</file>